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20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50" d="100"/>
          <a:sy n="150" d="100"/>
        </p:scale>
        <p:origin x="-294" y="1236"/>
      </p:cViewPr>
      <p:guideLst>
        <p:guide orient="horz" pos="2880"/>
        <p:guide pos="22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1225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5823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8051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02504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0566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4739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9313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7363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916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6804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4491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AACB3-0B1F-4A96-9F55-119A43E424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C7425-973E-4688-BD07-04A4E7A94B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5500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openxmlformats.org/officeDocument/2006/relationships/image" Target="../media/image27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12" Type="http://schemas.openxmlformats.org/officeDocument/2006/relationships/image" Target="../media/image26.png"/><Relationship Id="rId2" Type="http://schemas.openxmlformats.org/officeDocument/2006/relationships/image" Target="../media/image16.png"/><Relationship Id="rId16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png"/><Relationship Id="rId11" Type="http://schemas.openxmlformats.org/officeDocument/2006/relationships/image" Target="../media/image25.png"/><Relationship Id="rId5" Type="http://schemas.openxmlformats.org/officeDocument/2006/relationships/image" Target="../media/image19.png"/><Relationship Id="rId15" Type="http://schemas.openxmlformats.org/officeDocument/2006/relationships/image" Target="../media/image29.png"/><Relationship Id="rId10" Type="http://schemas.openxmlformats.org/officeDocument/2006/relationships/image" Target="../media/image24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Relationship Id="rId14" Type="http://schemas.openxmlformats.org/officeDocument/2006/relationships/image" Target="../media/image2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13" Type="http://schemas.openxmlformats.org/officeDocument/2006/relationships/image" Target="../media/image42.png"/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12" Type="http://schemas.openxmlformats.org/officeDocument/2006/relationships/image" Target="../media/image41.png"/><Relationship Id="rId2" Type="http://schemas.openxmlformats.org/officeDocument/2006/relationships/image" Target="../media/image31.png"/><Relationship Id="rId16" Type="http://schemas.openxmlformats.org/officeDocument/2006/relationships/image" Target="../media/image4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11" Type="http://schemas.openxmlformats.org/officeDocument/2006/relationships/image" Target="../media/image40.png"/><Relationship Id="rId5" Type="http://schemas.openxmlformats.org/officeDocument/2006/relationships/image" Target="../media/image34.png"/><Relationship Id="rId15" Type="http://schemas.openxmlformats.org/officeDocument/2006/relationships/image" Target="../media/image44.png"/><Relationship Id="rId10" Type="http://schemas.openxmlformats.org/officeDocument/2006/relationships/image" Target="../media/image39.png"/><Relationship Id="rId4" Type="http://schemas.openxmlformats.org/officeDocument/2006/relationships/image" Target="../media/image33.png"/><Relationship Id="rId9" Type="http://schemas.openxmlformats.org/officeDocument/2006/relationships/image" Target="../media/image38.png"/><Relationship Id="rId14" Type="http://schemas.openxmlformats.org/officeDocument/2006/relationships/image" Target="../media/image4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png"/><Relationship Id="rId13" Type="http://schemas.openxmlformats.org/officeDocument/2006/relationships/image" Target="../media/image57.png"/><Relationship Id="rId3" Type="http://schemas.openxmlformats.org/officeDocument/2006/relationships/image" Target="../media/image47.png"/><Relationship Id="rId7" Type="http://schemas.openxmlformats.org/officeDocument/2006/relationships/image" Target="../media/image51.png"/><Relationship Id="rId12" Type="http://schemas.openxmlformats.org/officeDocument/2006/relationships/image" Target="../media/image56.png"/><Relationship Id="rId2" Type="http://schemas.openxmlformats.org/officeDocument/2006/relationships/image" Target="../media/image46.png"/><Relationship Id="rId16" Type="http://schemas.openxmlformats.org/officeDocument/2006/relationships/image" Target="../media/image6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png"/><Relationship Id="rId11" Type="http://schemas.openxmlformats.org/officeDocument/2006/relationships/image" Target="../media/image55.png"/><Relationship Id="rId5" Type="http://schemas.openxmlformats.org/officeDocument/2006/relationships/image" Target="../media/image49.png"/><Relationship Id="rId15" Type="http://schemas.openxmlformats.org/officeDocument/2006/relationships/image" Target="../media/image59.png"/><Relationship Id="rId10" Type="http://schemas.openxmlformats.org/officeDocument/2006/relationships/image" Target="../media/image54.png"/><Relationship Id="rId4" Type="http://schemas.openxmlformats.org/officeDocument/2006/relationships/image" Target="../media/image48.png"/><Relationship Id="rId9" Type="http://schemas.openxmlformats.org/officeDocument/2006/relationships/image" Target="../media/image53.png"/><Relationship Id="rId14" Type="http://schemas.openxmlformats.org/officeDocument/2006/relationships/image" Target="../media/image5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png"/><Relationship Id="rId13" Type="http://schemas.openxmlformats.org/officeDocument/2006/relationships/image" Target="../media/image72.png"/><Relationship Id="rId3" Type="http://schemas.openxmlformats.org/officeDocument/2006/relationships/image" Target="../media/image62.png"/><Relationship Id="rId7" Type="http://schemas.openxmlformats.org/officeDocument/2006/relationships/image" Target="../media/image66.png"/><Relationship Id="rId12" Type="http://schemas.openxmlformats.org/officeDocument/2006/relationships/image" Target="../media/image71.png"/><Relationship Id="rId2" Type="http://schemas.openxmlformats.org/officeDocument/2006/relationships/image" Target="../media/image61.png"/><Relationship Id="rId16" Type="http://schemas.openxmlformats.org/officeDocument/2006/relationships/image" Target="../media/image7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5.png"/><Relationship Id="rId11" Type="http://schemas.openxmlformats.org/officeDocument/2006/relationships/image" Target="../media/image70.png"/><Relationship Id="rId5" Type="http://schemas.openxmlformats.org/officeDocument/2006/relationships/image" Target="../media/image64.png"/><Relationship Id="rId15" Type="http://schemas.openxmlformats.org/officeDocument/2006/relationships/image" Target="../media/image74.png"/><Relationship Id="rId10" Type="http://schemas.openxmlformats.org/officeDocument/2006/relationships/image" Target="../media/image69.png"/><Relationship Id="rId4" Type="http://schemas.openxmlformats.org/officeDocument/2006/relationships/image" Target="../media/image63.png"/><Relationship Id="rId9" Type="http://schemas.openxmlformats.org/officeDocument/2006/relationships/image" Target="../media/image68.png"/><Relationship Id="rId14" Type="http://schemas.openxmlformats.org/officeDocument/2006/relationships/image" Target="../media/image7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png"/><Relationship Id="rId7" Type="http://schemas.openxmlformats.org/officeDocument/2006/relationships/image" Target="../media/image81.png"/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0.png"/><Relationship Id="rId5" Type="http://schemas.openxmlformats.org/officeDocument/2006/relationships/image" Target="../media/image79.png"/><Relationship Id="rId4" Type="http://schemas.openxmlformats.org/officeDocument/2006/relationships/image" Target="../media/image7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0" name="Picture 1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5417" y="5864038"/>
            <a:ext cx="2229109" cy="1606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46947" y="5949637"/>
            <a:ext cx="2123942" cy="1500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0390" y="1108002"/>
            <a:ext cx="2104930" cy="16987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0700" y="923449"/>
            <a:ext cx="2160239" cy="19024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559" y="1120618"/>
            <a:ext cx="2072706" cy="16561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038" y="2825855"/>
            <a:ext cx="2153334" cy="14510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7647" y="2806718"/>
            <a:ext cx="2113233" cy="14510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0700" y="2770713"/>
            <a:ext cx="2260189" cy="1523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1424" y="4355436"/>
            <a:ext cx="2176007" cy="1523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5417" y="4314270"/>
            <a:ext cx="2176007" cy="1523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343" y="4453965"/>
            <a:ext cx="2014661" cy="1383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343" y="5933009"/>
            <a:ext cx="2073132" cy="14510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377" y="7466676"/>
            <a:ext cx="2139106" cy="14972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71352" y="7502537"/>
            <a:ext cx="2139106" cy="14972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3" name="Picture 19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9804" y="7502537"/>
            <a:ext cx="2094363" cy="14659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4" name="TextBox 6"/>
          <p:cNvSpPr txBox="1"/>
          <p:nvPr/>
        </p:nvSpPr>
        <p:spPr>
          <a:xfrm>
            <a:off x="444965" y="697931"/>
            <a:ext cx="1080120" cy="372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45" name="TextBox 7"/>
          <p:cNvSpPr txBox="1"/>
          <p:nvPr/>
        </p:nvSpPr>
        <p:spPr>
          <a:xfrm>
            <a:off x="2497193" y="711975"/>
            <a:ext cx="1080120" cy="372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3" name="Rectangle 9"/>
          <p:cNvSpPr/>
          <p:nvPr/>
        </p:nvSpPr>
        <p:spPr>
          <a:xfrm>
            <a:off x="4351424" y="4336180"/>
            <a:ext cx="2205279" cy="1523107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Rectangle 10"/>
          <p:cNvSpPr/>
          <p:nvPr/>
        </p:nvSpPr>
        <p:spPr>
          <a:xfrm>
            <a:off x="4242572" y="5905749"/>
            <a:ext cx="2343404" cy="1523107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TextBox 11"/>
          <p:cNvSpPr txBox="1"/>
          <p:nvPr/>
        </p:nvSpPr>
        <p:spPr>
          <a:xfrm>
            <a:off x="229781" y="28883"/>
            <a:ext cx="659202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Individual correlation graphs for a</a:t>
            </a:r>
            <a:r>
              <a:rPr lang="en-GB" sz="1400" dirty="0" smtClean="0">
                <a:latin typeface="Symbol" panose="05050102010706020507" pitchFamily="18" charset="2"/>
              </a:rPr>
              <a:t>b</a:t>
            </a:r>
            <a:r>
              <a:rPr lang="en-GB" sz="1400" dirty="0" smtClean="0"/>
              <a:t>42 marker in each condition. R</a:t>
            </a:r>
            <a:r>
              <a:rPr lang="en-GB" sz="1400" baseline="30000" dirty="0" smtClean="0"/>
              <a:t>2</a:t>
            </a:r>
            <a:r>
              <a:rPr lang="en-GB" sz="1400" dirty="0" smtClean="0"/>
              <a:t> and p values are given in supplementary table 3. Red boxed graphs have p&lt;0.01 yellow squared p value 0.05-0.01</a:t>
            </a:r>
            <a:endParaRPr lang="en-GB" sz="1400" dirty="0"/>
          </a:p>
        </p:txBody>
      </p:sp>
      <p:sp>
        <p:nvSpPr>
          <p:cNvPr id="4" name="TextBox 44"/>
          <p:cNvSpPr txBox="1"/>
          <p:nvPr/>
        </p:nvSpPr>
        <p:spPr>
          <a:xfrm>
            <a:off x="4759966" y="832962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D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063023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528" y="410694"/>
            <a:ext cx="2202168" cy="15121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60848" y="384240"/>
            <a:ext cx="2279216" cy="1565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60661" y="336858"/>
            <a:ext cx="2304256" cy="16128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35823" y="1892143"/>
            <a:ext cx="2198095" cy="1584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09546" y="1851889"/>
            <a:ext cx="2320763" cy="16244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84" y="1942293"/>
            <a:ext cx="2176007" cy="1523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015" y="3509687"/>
            <a:ext cx="2165194" cy="1515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4859" y="3513246"/>
            <a:ext cx="2111963" cy="1522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8" name="Picture 10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0064" y="3425638"/>
            <a:ext cx="2336098" cy="16836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9" name="Picture 11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07315" y="5048000"/>
            <a:ext cx="2192293" cy="15799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3" name="Picture 15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3801" y="6681995"/>
            <a:ext cx="2115051" cy="1494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" name="Rectangle 12"/>
          <p:cNvSpPr/>
          <p:nvPr/>
        </p:nvSpPr>
        <p:spPr>
          <a:xfrm>
            <a:off x="4328639" y="1907343"/>
            <a:ext cx="2340721" cy="15231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6" name="Rectangle 13"/>
          <p:cNvSpPr/>
          <p:nvPr/>
        </p:nvSpPr>
        <p:spPr>
          <a:xfrm>
            <a:off x="4328639" y="3476319"/>
            <a:ext cx="2205279" cy="1548906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" name="Rectangle 14"/>
          <p:cNvSpPr/>
          <p:nvPr/>
        </p:nvSpPr>
        <p:spPr>
          <a:xfrm>
            <a:off x="4436822" y="5076056"/>
            <a:ext cx="2097096" cy="15231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Rectangle 15"/>
          <p:cNvSpPr/>
          <p:nvPr/>
        </p:nvSpPr>
        <p:spPr>
          <a:xfrm>
            <a:off x="193134" y="6704048"/>
            <a:ext cx="2048043" cy="1527083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24"/>
          <p:cNvSpPr txBox="1"/>
          <p:nvPr/>
        </p:nvSpPr>
        <p:spPr>
          <a:xfrm>
            <a:off x="692696" y="101446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11" name="TextBox 25"/>
          <p:cNvSpPr txBox="1"/>
          <p:nvPr/>
        </p:nvSpPr>
        <p:spPr>
          <a:xfrm>
            <a:off x="2770772" y="62814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12" name="TextBox 26"/>
          <p:cNvSpPr txBox="1"/>
          <p:nvPr/>
        </p:nvSpPr>
        <p:spPr>
          <a:xfrm>
            <a:off x="5151713" y="135031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D</a:t>
            </a:r>
            <a:endParaRPr lang="en-GB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936" y="5150792"/>
            <a:ext cx="2069817" cy="14483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0620" y="5072714"/>
            <a:ext cx="2158019" cy="15552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4920" y="6825930"/>
            <a:ext cx="1875854" cy="13254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1018" y="6698312"/>
            <a:ext cx="2056461" cy="14530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0142380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2" name="Picture 10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810" y="3497842"/>
            <a:ext cx="2113360" cy="1523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9" name="Picture 1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083" y="6694435"/>
            <a:ext cx="2259663" cy="1581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9080" y="372404"/>
            <a:ext cx="2278882" cy="15951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7746" y="539552"/>
            <a:ext cx="1845194" cy="12915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640" y="421322"/>
            <a:ext cx="2139106" cy="14972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640" y="1986287"/>
            <a:ext cx="2004810" cy="1403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3706" y="1890367"/>
            <a:ext cx="2213274" cy="15951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1797" y="1986287"/>
            <a:ext cx="2013447" cy="14510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1796" y="3397071"/>
            <a:ext cx="2315555" cy="1636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3450" y="3473118"/>
            <a:ext cx="2190439" cy="1547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3" name="Picture 11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810" y="5047898"/>
            <a:ext cx="2113360" cy="14792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4" name="Picture 12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9864" y="5075539"/>
            <a:ext cx="2176007" cy="1523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5" name="Picture 13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23321" y="4932039"/>
            <a:ext cx="2374030" cy="17109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7" name="Picture 15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75736" y="6804248"/>
            <a:ext cx="1915441" cy="13535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8" name="Picture 16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0524" y="6747653"/>
            <a:ext cx="2082286" cy="1500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836712" y="0"/>
            <a:ext cx="1080120" cy="372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28" name="TextBox 27"/>
          <p:cNvSpPr txBox="1"/>
          <p:nvPr/>
        </p:nvSpPr>
        <p:spPr>
          <a:xfrm>
            <a:off x="2888940" y="14044"/>
            <a:ext cx="1080120" cy="372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29" name="TextBox 28"/>
          <p:cNvSpPr txBox="1"/>
          <p:nvPr/>
        </p:nvSpPr>
        <p:spPr>
          <a:xfrm>
            <a:off x="5093711" y="-28846"/>
            <a:ext cx="1080120" cy="372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D</a:t>
            </a:r>
            <a:endParaRPr lang="en-GB" dirty="0"/>
          </a:p>
        </p:txBody>
      </p:sp>
      <p:sp>
        <p:nvSpPr>
          <p:cNvPr id="30" name="Rectangle 9"/>
          <p:cNvSpPr/>
          <p:nvPr/>
        </p:nvSpPr>
        <p:spPr>
          <a:xfrm>
            <a:off x="4291486" y="3387995"/>
            <a:ext cx="2305865" cy="16329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Rectangle 11"/>
          <p:cNvSpPr/>
          <p:nvPr/>
        </p:nvSpPr>
        <p:spPr>
          <a:xfrm>
            <a:off x="4312810" y="6664525"/>
            <a:ext cx="2205279" cy="16329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65759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970" y="361424"/>
            <a:ext cx="2162910" cy="14852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2121" y="180965"/>
            <a:ext cx="2637558" cy="18111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93096" y="370466"/>
            <a:ext cx="2218098" cy="1523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88054" y="1898641"/>
            <a:ext cx="2196579" cy="15375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165" y="1765335"/>
            <a:ext cx="2278882" cy="15951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7268" y="1817872"/>
            <a:ext cx="2278882" cy="15951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4" name="Picture 8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935" y="3353847"/>
            <a:ext cx="2190512" cy="15332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5" name="Picture 9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1102" y="3353847"/>
            <a:ext cx="2226952" cy="15587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6" name="Picture 10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42920" y="3412987"/>
            <a:ext cx="2272895" cy="15909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7" name="Picture 11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5307" y="4919216"/>
            <a:ext cx="2532693" cy="17391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9" name="Picture 13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773" y="5105646"/>
            <a:ext cx="2113233" cy="14510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10" name="Picture 14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4370" y="6804248"/>
            <a:ext cx="1920416" cy="13442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11" name="Picture 15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4785" y="6556745"/>
            <a:ext cx="2421365" cy="16948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12" name="Picture 16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1738" y="6613022"/>
            <a:ext cx="2260561" cy="15822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836712" y="0"/>
            <a:ext cx="1080120" cy="372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27" name="TextBox 26"/>
          <p:cNvSpPr txBox="1"/>
          <p:nvPr/>
        </p:nvSpPr>
        <p:spPr>
          <a:xfrm>
            <a:off x="2888940" y="14044"/>
            <a:ext cx="1080120" cy="372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28" name="TextBox 27"/>
          <p:cNvSpPr txBox="1"/>
          <p:nvPr/>
        </p:nvSpPr>
        <p:spPr>
          <a:xfrm>
            <a:off x="5093711" y="-28846"/>
            <a:ext cx="1080120" cy="372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D</a:t>
            </a:r>
            <a:endParaRPr lang="en-GB" dirty="0"/>
          </a:p>
        </p:txBody>
      </p:sp>
      <p:sp>
        <p:nvSpPr>
          <p:cNvPr id="29" name="Rectangle 1"/>
          <p:cNvSpPr/>
          <p:nvPr/>
        </p:nvSpPr>
        <p:spPr>
          <a:xfrm>
            <a:off x="4419491" y="6657540"/>
            <a:ext cx="2205279" cy="16329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108" name="Picture 12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61965" y="5056106"/>
            <a:ext cx="2257526" cy="15501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8304175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0106" y="290926"/>
            <a:ext cx="2408837" cy="17021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64582" y="290926"/>
            <a:ext cx="2359258" cy="16671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640" y="466773"/>
            <a:ext cx="2053548" cy="14510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6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640" y="1925446"/>
            <a:ext cx="2232248" cy="15773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7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1800" y="1907705"/>
            <a:ext cx="2257354" cy="15951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8" name="Picture 8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0106" y="1958049"/>
            <a:ext cx="2139969" cy="15121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9" name="Picture 9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8783" y="3459536"/>
            <a:ext cx="2213274" cy="15951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0" name="Picture 10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19940" y="3587692"/>
            <a:ext cx="2003888" cy="14442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1" name="Picture 11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690" y="3587692"/>
            <a:ext cx="2013447" cy="14510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2" name="Picture 12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415" y="5054651"/>
            <a:ext cx="2322963" cy="15951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3" name="Picture 13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9895" y="5031902"/>
            <a:ext cx="2237124" cy="15361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4" name="Picture 14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72319" y="4985021"/>
            <a:ext cx="2373666" cy="16299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5" name="Picture 15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8975" y="6721774"/>
            <a:ext cx="2176007" cy="1523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6" name="Picture 16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56208" y="6649766"/>
            <a:ext cx="2176007" cy="1523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7" name="Picture 17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005" y="6721774"/>
            <a:ext cx="2073132" cy="14510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" name="TextBox 26"/>
          <p:cNvSpPr txBox="1"/>
          <p:nvPr/>
        </p:nvSpPr>
        <p:spPr>
          <a:xfrm>
            <a:off x="836712" y="0"/>
            <a:ext cx="1080120" cy="372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28" name="TextBox 27"/>
          <p:cNvSpPr txBox="1"/>
          <p:nvPr/>
        </p:nvSpPr>
        <p:spPr>
          <a:xfrm>
            <a:off x="2888940" y="14044"/>
            <a:ext cx="1080120" cy="372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29" name="TextBox 28"/>
          <p:cNvSpPr txBox="1"/>
          <p:nvPr/>
        </p:nvSpPr>
        <p:spPr>
          <a:xfrm>
            <a:off x="5093711" y="-28846"/>
            <a:ext cx="1080120" cy="372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D</a:t>
            </a:r>
            <a:endParaRPr lang="en-GB" dirty="0"/>
          </a:p>
        </p:txBody>
      </p:sp>
      <p:sp>
        <p:nvSpPr>
          <p:cNvPr id="30" name="Rectangle 1"/>
          <p:cNvSpPr/>
          <p:nvPr/>
        </p:nvSpPr>
        <p:spPr>
          <a:xfrm>
            <a:off x="4328639" y="3476319"/>
            <a:ext cx="2205279" cy="163295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Rectangle 10"/>
          <p:cNvSpPr/>
          <p:nvPr/>
        </p:nvSpPr>
        <p:spPr>
          <a:xfrm>
            <a:off x="4397547" y="1993083"/>
            <a:ext cx="2205279" cy="14496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44222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845" y="410694"/>
            <a:ext cx="2176007" cy="1523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32073" y="389374"/>
            <a:ext cx="2221263" cy="15547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9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705" y="2108078"/>
            <a:ext cx="2322963" cy="15951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52" name="Picture 8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5104" y="2068177"/>
            <a:ext cx="2322963" cy="15951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836712" y="0"/>
            <a:ext cx="1080120" cy="372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2888940" y="14044"/>
            <a:ext cx="1080120" cy="372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BD</a:t>
            </a:r>
            <a:endParaRPr lang="en-GB" dirty="0"/>
          </a:p>
        </p:txBody>
      </p:sp>
      <p:sp>
        <p:nvSpPr>
          <p:cNvPr id="20" name="TextBox 19"/>
          <p:cNvSpPr txBox="1"/>
          <p:nvPr/>
        </p:nvSpPr>
        <p:spPr>
          <a:xfrm>
            <a:off x="5093711" y="-28846"/>
            <a:ext cx="1080120" cy="3724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D</a:t>
            </a:r>
            <a:endParaRPr lang="en-GB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2856" y="441368"/>
            <a:ext cx="2099217" cy="1468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1964" y="2108078"/>
            <a:ext cx="2285148" cy="1568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" name="Rectangle 1"/>
          <p:cNvSpPr/>
          <p:nvPr/>
        </p:nvSpPr>
        <p:spPr>
          <a:xfrm>
            <a:off x="4365104" y="2088530"/>
            <a:ext cx="2120104" cy="1554407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87835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2</TotalTime>
  <Words>49</Words>
  <Application>Microsoft Office PowerPoint</Application>
  <PresentationFormat>On-screen Show (4:3)</PresentationFormat>
  <Paragraphs>19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C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ndy Heywood</dc:creator>
  <cp:lastModifiedBy>Wendy Heywood</cp:lastModifiedBy>
  <cp:revision>41</cp:revision>
  <dcterms:created xsi:type="dcterms:W3CDTF">2015-11-03T13:39:46Z</dcterms:created>
  <dcterms:modified xsi:type="dcterms:W3CDTF">2015-11-12T10:44:36Z</dcterms:modified>
</cp:coreProperties>
</file>